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6" r:id="rId2"/>
    <p:sldId id="268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0000FF"/>
    <a:srgbClr val="4B4BDC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2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6A9202-B8B8-489E-B326-C97E93500D15}" type="datetimeFigureOut">
              <a:rPr lang="es-ES" smtClean="0"/>
              <a:t>23/5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8D1C05-BF7E-4A4F-A6BB-177A444D096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393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1E256B-1557-46D9-AD2B-09986B9C30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F7ED5B5-5F8E-43B0-965B-DC748ADA6F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857BF97-EC78-4334-9999-C6C081FC2D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7C9031-11F0-4DD5-97F2-6E60757D39A8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0D38C33-4BB1-48B7-9BF8-3AB339DE9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07C5051-52F3-46CC-A0A2-50F52CA8C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0588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F3D863B-49BC-4581-B9F0-E3B4C06F3E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34C72F6E-73E5-4F0F-8B7E-22CF8ACD15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1306AB1-E351-42AE-A60D-D4B2CC909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95605-CE3C-4CA9-9FCB-F7316D049E13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EB65878-F0E3-4344-97B7-9E55AB5E8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994AC8A-64AE-4744-A310-7868DD30E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36172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7B00C68-943B-4AED-BAA8-347B9D304A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A27C2DB-C01C-4A95-8987-A40CA7163E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ECA1B67-CAD1-42FA-AE52-6BED3FCBF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DB8088-357A-4DE9-AA3C-CB671B0BEFC9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5859287-ACB0-4451-BE5D-877166A78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833911-C6F7-445C-9E69-2B7E0ADA5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7797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86207C-6805-43FB-9E0E-874CA4A5B8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FA12CF4-E8A2-4DD5-85F9-3545A5420A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4EDEC9C-4E43-4CA9-BFD1-414162C61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F5B91-9897-49CD-AB79-2C35228F8C45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246FEE5-A9FF-48B1-BDBE-D46D068E0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6F35BAF-34DD-4ED2-B9D3-D9EC4A31E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664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710498-21A9-4410-A3E4-99C6DCB9A6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4C157EB-3591-4292-A5D2-F8B96C1F9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D9B29A7-31AB-422E-9086-1C701756DA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0CC53-9163-421D-9752-22726528D587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4F58FED-FBE1-4212-90A4-6770802467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3449422-081A-41D0-8FD1-E46F6BAA0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0955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22BD96-CC8E-41B9-9329-C186B8321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10322CB-D368-472D-91B3-25E36FB915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CFD20BC-2C94-481E-B80C-E134FB1BF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AEA4613-CC0A-4ACC-91AA-8EA29968A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CF4E5-5342-4CC0-8CF2-1A19D5DB37B4}" type="datetime1">
              <a:rPr lang="es-ES" smtClean="0"/>
              <a:t>23/5/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C6FA8D5-ED5C-475C-B557-087C0F480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D3771CE-052B-4FBA-A10E-5222C2726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0205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6491067-FE40-4E36-AF29-26660EF08F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0C1ED08-BCCB-4A5E-AE10-3C4ABDD610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D31603-B9AE-41EB-AD6A-E7E7EFE69E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661F467-2F2A-4390-BCD5-B6CA08DC28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B5B909F8-5292-40A7-9739-0ADFF98FBE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2C893E4-8646-4185-84CB-85A8D98D7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63C12-C3AF-4FA8-89C4-A29174615F96}" type="datetime1">
              <a:rPr lang="es-ES" smtClean="0"/>
              <a:t>23/5/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FD8D96F1-E881-4A7D-8E73-13A380F27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E78DD823-BBA6-4E94-AC3D-F2BF26B91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0468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46DB16-D73C-4F8F-844A-9E2C839322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B5FFB10-77AC-4A01-9196-DCD02730B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E6896-DDE0-4D64-94CB-A5B417676F09}" type="datetime1">
              <a:rPr lang="es-ES" smtClean="0"/>
              <a:t>23/5/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4B1B3ED-957E-4E15-81A9-B2B32E877E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4EAA912-948E-4510-B187-A9304E283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9792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48636233-4DF9-4E18-8D94-EBFC2A51C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15E1EB-E582-4E65-AD09-53B063BA4FE7}" type="datetime1">
              <a:rPr lang="es-ES" smtClean="0"/>
              <a:t>23/5/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1B8C0D5-F420-4020-A72C-2342E99A8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68C99F82-587F-47B5-BF32-B51A9FDAF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1339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7270B6-E3DD-4DBC-BF4C-148D55069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4032AC2-2C39-49D8-BB0E-ED409ABE11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A4FCC91-C725-4EF3-BF9A-E037784ED6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5343A6-57E1-4DAA-9033-F3E4938B5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104E3B-DDD0-4EE7-8A2D-B55056499394}" type="datetime1">
              <a:rPr lang="es-ES" smtClean="0"/>
              <a:t>23/5/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036EE57-577C-434D-93C4-AE73E70EE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17B3470-29CC-4773-8F2B-B0C7F2435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82928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1388CB2-57CF-4EBB-AA70-B8982957A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281D6680-0650-4B69-B996-EB964406C2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1A45471-1C48-46EB-AE68-7AC9C55F3C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F433CD2-5B21-40C9-9556-34D085540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646A8F-346A-4103-8000-A3B805758BFF}" type="datetime1">
              <a:rPr lang="es-ES" smtClean="0"/>
              <a:t>23/5/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ECCB997-F816-4164-B41A-62EDFCAC0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AE8087C-A5A2-4A8E-B0DC-D6944766A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5274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8663EB1-F182-484E-A766-8149EB405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1A2BEA-6D83-4986-8E5C-041715F87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C19BA6A-234B-4C00-971C-0891163B8B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A829E9-6332-4EC3-A97F-E619761BFBB2}" type="datetime1">
              <a:rPr lang="es-ES" smtClean="0"/>
              <a:t>23/5/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62E7755-4F1C-4BFC-9A5F-6F800132D7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BDDE07-4D30-4B04-AA74-0E16CA0726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38516-EC0D-484E-8F38-E3915436FF70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9486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número de diapositiva 1">
            <a:extLst>
              <a:ext uri="{FF2B5EF4-FFF2-40B4-BE49-F238E27FC236}">
                <a16:creationId xmlns:a16="http://schemas.microsoft.com/office/drawing/2014/main" id="{70CD0BFC-252D-423D-96CF-05EBD68D0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3138516-EC0D-484E-8F38-E3915436FF70}" type="slidenum">
              <a:rPr kumimoji="0" lang="es-E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s-E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Sp1-noForce-traj1">
            <a:hlinkClick r:id="" action="ppaction://media"/>
            <a:extLst>
              <a:ext uri="{FF2B5EF4-FFF2-40B4-BE49-F238E27FC236}">
                <a16:creationId xmlns:a16="http://schemas.microsoft.com/office/drawing/2014/main" id="{6077F2CF-E48E-4106-A46D-2C0A6F4FDD6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817648" y="1877584"/>
            <a:ext cx="9043639" cy="3528992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1725453" y="433201"/>
            <a:ext cx="913583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Evolution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of a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rajectory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MaSp1a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fragment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initial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referenc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conformation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equilibrium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conformation</a:t>
            </a:r>
            <a:endParaRPr 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6174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929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número de diapositiva 1">
            <a:extLst>
              <a:ext uri="{FF2B5EF4-FFF2-40B4-BE49-F238E27FC236}">
                <a16:creationId xmlns:a16="http://schemas.microsoft.com/office/drawing/2014/main" id="{70CD0BFC-252D-423D-96CF-05EBD68D0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3138516-EC0D-484E-8F38-E3915436FF70}" type="slidenum">
              <a:rPr kumimoji="0" lang="es-E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s-E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CuadroTexto 6"/>
          <p:cNvSpPr txBox="1"/>
          <p:nvPr/>
        </p:nvSpPr>
        <p:spPr>
          <a:xfrm>
            <a:off x="1629273" y="433201"/>
            <a:ext cx="932819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Evolution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of a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rajectory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>
                <a:latin typeface="Arial" panose="020B0604020202020204" pitchFamily="34" charset="0"/>
                <a:cs typeface="Arial" panose="020B0604020202020204" pitchFamily="34" charset="0"/>
              </a:rPr>
              <a:t> MaSp2.2a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fragment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initial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referenc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conformation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equilibrium</a:t>
            </a:r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dirty="0" err="1">
                <a:latin typeface="Arial" panose="020B0604020202020204" pitchFamily="34" charset="0"/>
                <a:cs typeface="Arial" panose="020B0604020202020204" pitchFamily="34" charset="0"/>
              </a:rPr>
              <a:t>conformation</a:t>
            </a:r>
            <a:endParaRPr lang="es-E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Sp2-noForce-traj3">
            <a:hlinkClick r:id="" action="ppaction://media"/>
            <a:extLst>
              <a:ext uri="{FF2B5EF4-FFF2-40B4-BE49-F238E27FC236}">
                <a16:creationId xmlns:a16="http://schemas.microsoft.com/office/drawing/2014/main" id="{1B59ADEB-9560-4607-8D4C-6170C41E2E7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805473" y="1446524"/>
            <a:ext cx="9055814" cy="41779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42806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8899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0</TotalTime>
  <Words>36</Words>
  <Application>Microsoft Macintosh PowerPoint</Application>
  <PresentationFormat>Widescreen</PresentationFormat>
  <Paragraphs>6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FERNANDEZ PACIOS</dc:creator>
  <cp:lastModifiedBy>Cheryl Hayashi</cp:lastModifiedBy>
  <cp:revision>63</cp:revision>
  <dcterms:created xsi:type="dcterms:W3CDTF">2021-09-27T09:04:36Z</dcterms:created>
  <dcterms:modified xsi:type="dcterms:W3CDTF">2022-05-23T04:06:45Z</dcterms:modified>
</cp:coreProperties>
</file>